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3" autoAdjust="0"/>
    <p:restoredTop sz="94660"/>
  </p:normalViewPr>
  <p:slideViewPr>
    <p:cSldViewPr snapToGrid="0">
      <p:cViewPr varScale="1">
        <p:scale>
          <a:sx n="88" d="100"/>
          <a:sy n="88" d="100"/>
        </p:scale>
        <p:origin x="44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6331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136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6442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051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7770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5924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1115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2701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924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396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0109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BAF65-BF0A-43D5-B427-08A78D28B488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CDB75-B042-44BD-BBF4-405B76018C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9851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그룹 20">
            <a:extLst>
              <a:ext uri="{FF2B5EF4-FFF2-40B4-BE49-F238E27FC236}">
                <a16:creationId xmlns:a16="http://schemas.microsoft.com/office/drawing/2014/main" id="{E8B831A3-8A5C-4E2F-873F-50939E6DB9AE}"/>
              </a:ext>
            </a:extLst>
          </p:cNvPr>
          <p:cNvGrpSpPr/>
          <p:nvPr/>
        </p:nvGrpSpPr>
        <p:grpSpPr>
          <a:xfrm>
            <a:off x="418385" y="851653"/>
            <a:ext cx="11132337" cy="4087227"/>
            <a:chOff x="960261" y="761278"/>
            <a:chExt cx="11132337" cy="4087227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A343645-2182-4D23-82FA-B7435B5B500C}"/>
                </a:ext>
              </a:extLst>
            </p:cNvPr>
            <p:cNvSpPr txBox="1"/>
            <p:nvPr/>
          </p:nvSpPr>
          <p:spPr>
            <a:xfrm>
              <a:off x="8571913" y="1408706"/>
              <a:ext cx="3116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10    2   10   2    10   2    10   2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4E185DF7-EC96-45D3-8F58-1EF10ED38F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flipH="1">
              <a:off x="8571913" y="1682754"/>
              <a:ext cx="3056843" cy="2807751"/>
            </a:xfrm>
            <a:prstGeom prst="rect">
              <a:avLst/>
            </a:prstGeom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233BC85C-C899-46D7-A3D3-389DA214E0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209" r="14039"/>
            <a:stretch/>
          </p:blipFill>
          <p:spPr>
            <a:xfrm>
              <a:off x="5131059" y="1675349"/>
              <a:ext cx="2844541" cy="2837661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7F916F1D-C699-477D-80FC-35B3D2E996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9" r="24707"/>
            <a:stretch/>
          </p:blipFill>
          <p:spPr>
            <a:xfrm>
              <a:off x="1524000" y="1670316"/>
              <a:ext cx="2844541" cy="283262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F6DDA20-5B27-4BC2-8617-5391354F6EAD}"/>
                </a:ext>
              </a:extLst>
            </p:cNvPr>
            <p:cNvSpPr txBox="1"/>
            <p:nvPr/>
          </p:nvSpPr>
          <p:spPr>
            <a:xfrm>
              <a:off x="1828196" y="1147633"/>
              <a:ext cx="27686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        NA      </a:t>
              </a:r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HANA      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</a:p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B731A8A-59C2-405F-9673-203B92EF0296}"/>
                </a:ext>
              </a:extLst>
            </p:cNvPr>
            <p:cNvSpPr txBox="1"/>
            <p:nvPr/>
          </p:nvSpPr>
          <p:spPr>
            <a:xfrm>
              <a:off x="1688237" y="1409243"/>
              <a:ext cx="32940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10    2   10   2    10   2     10   2 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B8449C8-A52F-426D-96FC-1DC9A5E8FEE9}"/>
                </a:ext>
              </a:extLst>
            </p:cNvPr>
            <p:cNvSpPr txBox="1"/>
            <p:nvPr/>
          </p:nvSpPr>
          <p:spPr>
            <a:xfrm>
              <a:off x="5481806" y="1147096"/>
              <a:ext cx="27686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        NA      HANA     M1</a:t>
              </a:r>
            </a:p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1ACEE79-460A-4C5D-B127-A76467775DB4}"/>
                </a:ext>
              </a:extLst>
            </p:cNvPr>
            <p:cNvSpPr txBox="1"/>
            <p:nvPr/>
          </p:nvSpPr>
          <p:spPr>
            <a:xfrm>
              <a:off x="5341847" y="1408706"/>
              <a:ext cx="3116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10    2   10   2    10   2    10   2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B2AA0C5-3904-4810-8036-464E4B6B0D30}"/>
                </a:ext>
              </a:extLst>
            </p:cNvPr>
            <p:cNvSpPr txBox="1"/>
            <p:nvPr/>
          </p:nvSpPr>
          <p:spPr>
            <a:xfrm>
              <a:off x="8711871" y="1147096"/>
              <a:ext cx="319308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        NA      HANA     M1</a:t>
              </a:r>
            </a:p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1FE91BC-FF1D-44B3-BED5-FA8A98CF053F}"/>
                </a:ext>
              </a:extLst>
            </p:cNvPr>
            <p:cNvSpPr txBox="1"/>
            <p:nvPr/>
          </p:nvSpPr>
          <p:spPr>
            <a:xfrm>
              <a:off x="960261" y="761278"/>
              <a:ext cx="107783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/>
                <a:t>A. HA                                      B. NA                                     C. M1 </a:t>
              </a:r>
              <a:endParaRPr lang="ko-KR" altLang="en-US" b="1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67E0993-7DCB-46D6-A644-E6D3F0B2A776}"/>
                </a:ext>
              </a:extLst>
            </p:cNvPr>
            <p:cNvSpPr txBox="1"/>
            <p:nvPr/>
          </p:nvSpPr>
          <p:spPr>
            <a:xfrm>
              <a:off x="1471810" y="1435636"/>
              <a:ext cx="2968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03C29FB-9269-4510-9734-36780B568299}"/>
                </a:ext>
              </a:extLst>
            </p:cNvPr>
            <p:cNvSpPr txBox="1"/>
            <p:nvPr/>
          </p:nvSpPr>
          <p:spPr>
            <a:xfrm>
              <a:off x="5147419" y="1461765"/>
              <a:ext cx="2968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70F2556-B20D-4F4D-8D12-945ED0482331}"/>
                </a:ext>
              </a:extLst>
            </p:cNvPr>
            <p:cNvSpPr txBox="1"/>
            <p:nvPr/>
          </p:nvSpPr>
          <p:spPr>
            <a:xfrm>
              <a:off x="11242649" y="1475005"/>
              <a:ext cx="2968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A502169-94FA-4A5D-B24C-F8E4AB008647}"/>
                </a:ext>
              </a:extLst>
            </p:cNvPr>
            <p:cNvSpPr txBox="1"/>
            <p:nvPr/>
          </p:nvSpPr>
          <p:spPr>
            <a:xfrm>
              <a:off x="1022434" y="1778926"/>
              <a:ext cx="727976" cy="2400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altLang="ko-KR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F9A8E16-D9BC-4A52-A85F-A540C68824C5}"/>
                </a:ext>
              </a:extLst>
            </p:cNvPr>
            <p:cNvSpPr txBox="1"/>
            <p:nvPr/>
          </p:nvSpPr>
          <p:spPr>
            <a:xfrm>
              <a:off x="4649153" y="1893850"/>
              <a:ext cx="727976" cy="2954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altLang="ko-KR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E2CE410-851E-473F-9AED-7FEF34A0EEAD}"/>
                </a:ext>
              </a:extLst>
            </p:cNvPr>
            <p:cNvSpPr txBox="1"/>
            <p:nvPr/>
          </p:nvSpPr>
          <p:spPr>
            <a:xfrm>
              <a:off x="11364622" y="2037891"/>
              <a:ext cx="727976" cy="24160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altLang="ko-KR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</a:p>
            <a:p>
              <a:pPr algn="ctr"/>
              <a:endParaRPr lang="en-US" altLang="ko-KR" sz="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322528" y="84331"/>
            <a:ext cx="11040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u="sng" dirty="0"/>
              <a:t>Supplementary </a:t>
            </a:r>
            <a:r>
              <a:rPr lang="en-US" altLang="ko-KR" b="1" u="sng" dirty="0" smtClean="0"/>
              <a:t>materials: Confirming successful expression of HA, NA, and M1 in the VLPs </a:t>
            </a:r>
            <a:endParaRPr lang="ko-KR" altLang="en-US" b="1" u="sng" dirty="0"/>
          </a:p>
        </p:txBody>
      </p:sp>
      <p:sp>
        <p:nvSpPr>
          <p:cNvPr id="2" name="TextBox 1"/>
          <p:cNvSpPr txBox="1"/>
          <p:nvPr/>
        </p:nvSpPr>
        <p:spPr>
          <a:xfrm>
            <a:off x="480558" y="4970960"/>
            <a:ext cx="112438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Palatino Linotype" panose="02040502050505030304" pitchFamily="18" charset="0"/>
              </a:rPr>
              <a:t>Figure S1. Western </a:t>
            </a:r>
            <a:r>
              <a:rPr lang="en-US" altLang="ko-KR" dirty="0">
                <a:latin typeface="Palatino Linotype" panose="02040502050505030304" pitchFamily="18" charset="0"/>
              </a:rPr>
              <a:t>blot showing all the bands with all molecular weight markers. VLPs containing HA, NA, both HA and NA, and M1 were characterized using Western blot. The 10 and 2 </a:t>
            </a:r>
            <a:r>
              <a:rPr lang="en-US" altLang="ko-KR" dirty="0" err="1">
                <a:latin typeface="Palatino Linotype" panose="02040502050505030304" pitchFamily="18" charset="0"/>
              </a:rPr>
              <a:t>μg</a:t>
            </a:r>
            <a:r>
              <a:rPr lang="en-US" altLang="ko-KR" dirty="0">
                <a:latin typeface="Palatino Linotype" panose="02040502050505030304" pitchFamily="18" charset="0"/>
              </a:rPr>
              <a:t> VLPs were loaded per lane as indicated. Polyclonal mouse anti-H5N1 antibody was used to probe HA protein (A); anti-NA monoclonal antibody (HCA-2) and anti-M1 (GA2B) were used to probe NA (B) and M1 (C), respectively. </a:t>
            </a:r>
          </a:p>
          <a:p>
            <a:endParaRPr lang="en-US" altLang="ko-KR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080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76</Words>
  <Application>Microsoft Office PowerPoint</Application>
  <PresentationFormat>Widescreen</PresentationFormat>
  <Paragraphs>8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Palatino Linotype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.com Authorization Update</dc:creator>
  <cp:lastModifiedBy>Chu</cp:lastModifiedBy>
  <cp:revision>7</cp:revision>
  <dcterms:created xsi:type="dcterms:W3CDTF">2021-08-17T02:30:25Z</dcterms:created>
  <dcterms:modified xsi:type="dcterms:W3CDTF">2021-10-07T01:54:04Z</dcterms:modified>
</cp:coreProperties>
</file>